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4"/>
  </p:notesMasterIdLst>
  <p:sldIdLst>
    <p:sldId id="256" r:id="rId2"/>
    <p:sldId id="278" r:id="rId3"/>
    <p:sldId id="273" r:id="rId4"/>
    <p:sldId id="274" r:id="rId5"/>
    <p:sldId id="275" r:id="rId6"/>
    <p:sldId id="276" r:id="rId7"/>
    <p:sldId id="267" r:id="rId8"/>
    <p:sldId id="270" r:id="rId9"/>
    <p:sldId id="271" r:id="rId10"/>
    <p:sldId id="272" r:id="rId11"/>
    <p:sldId id="269" r:id="rId12"/>
    <p:sldId id="263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5695FBC-71C7-4208-98E4-2EA2991D4161}" v="28" dt="2024-11-13T01:15:36.83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0" d="100"/>
          <a:sy n="70" d="100"/>
        </p:scale>
        <p:origin x="512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20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everine Lamon" userId="ff329eb7-2761-407d-b01e-994c500efbc1" providerId="ADAL" clId="{95695FBC-71C7-4208-98E4-2EA2991D4161}"/>
    <pc:docChg chg="undo custSel addSld delSld modSld">
      <pc:chgData name="Severine Lamon" userId="ff329eb7-2761-407d-b01e-994c500efbc1" providerId="ADAL" clId="{95695FBC-71C7-4208-98E4-2EA2991D4161}" dt="2024-11-13T01:15:36.834" v="250" actId="164"/>
      <pc:docMkLst>
        <pc:docMk/>
      </pc:docMkLst>
      <pc:sldChg chg="addSp delSp modSp mod">
        <pc:chgData name="Severine Lamon" userId="ff329eb7-2761-407d-b01e-994c500efbc1" providerId="ADAL" clId="{95695FBC-71C7-4208-98E4-2EA2991D4161}" dt="2024-11-13T00:45:16.470" v="181" actId="20577"/>
        <pc:sldMkLst>
          <pc:docMk/>
          <pc:sldMk cId="1122470115" sldId="261"/>
        </pc:sldMkLst>
        <pc:spChg chg="del">
          <ac:chgData name="Severine Lamon" userId="ff329eb7-2761-407d-b01e-994c500efbc1" providerId="ADAL" clId="{95695FBC-71C7-4208-98E4-2EA2991D4161}" dt="2024-11-13T00:34:56.077" v="133" actId="21"/>
          <ac:spMkLst>
            <pc:docMk/>
            <pc:sldMk cId="1122470115" sldId="261"/>
            <ac:spMk id="3" creationId="{3363575A-31A0-5A6A-3AC5-7F20083CC554}"/>
          </ac:spMkLst>
        </pc:spChg>
        <pc:spChg chg="add mod">
          <ac:chgData name="Severine Lamon" userId="ff329eb7-2761-407d-b01e-994c500efbc1" providerId="ADAL" clId="{95695FBC-71C7-4208-98E4-2EA2991D4161}" dt="2024-11-13T00:45:16.470" v="181" actId="20577"/>
          <ac:spMkLst>
            <pc:docMk/>
            <pc:sldMk cId="1122470115" sldId="261"/>
            <ac:spMk id="4" creationId="{532F903F-3FF7-2CF7-7C46-2A5BE4F4A9D8}"/>
          </ac:spMkLst>
        </pc:spChg>
      </pc:sldChg>
      <pc:sldChg chg="addSp delSp modSp mod">
        <pc:chgData name="Severine Lamon" userId="ff329eb7-2761-407d-b01e-994c500efbc1" providerId="ADAL" clId="{95695FBC-71C7-4208-98E4-2EA2991D4161}" dt="2024-11-13T00:59:48.609" v="201" actId="20577"/>
        <pc:sldMkLst>
          <pc:docMk/>
          <pc:sldMk cId="2722031128" sldId="262"/>
        </pc:sldMkLst>
        <pc:spChg chg="add del mod">
          <ac:chgData name="Severine Lamon" userId="ff329eb7-2761-407d-b01e-994c500efbc1" providerId="ADAL" clId="{95695FBC-71C7-4208-98E4-2EA2991D4161}" dt="2024-11-13T00:42:52.040" v="178" actId="478"/>
          <ac:spMkLst>
            <pc:docMk/>
            <pc:sldMk cId="2722031128" sldId="262"/>
            <ac:spMk id="2" creationId="{DA945D09-198D-02FB-562F-398D0B57DA5E}"/>
          </ac:spMkLst>
        </pc:spChg>
        <pc:spChg chg="del mod">
          <ac:chgData name="Severine Lamon" userId="ff329eb7-2761-407d-b01e-994c500efbc1" providerId="ADAL" clId="{95695FBC-71C7-4208-98E4-2EA2991D4161}" dt="2024-11-13T00:34:49.705" v="130" actId="21"/>
          <ac:spMkLst>
            <pc:docMk/>
            <pc:sldMk cId="2722031128" sldId="262"/>
            <ac:spMk id="5" creationId="{FB450F13-A767-39C9-0B2E-5D0F8363A377}"/>
          </ac:spMkLst>
        </pc:spChg>
        <pc:spChg chg="add mod">
          <ac:chgData name="Severine Lamon" userId="ff329eb7-2761-407d-b01e-994c500efbc1" providerId="ADAL" clId="{95695FBC-71C7-4208-98E4-2EA2991D4161}" dt="2024-11-13T00:59:30.626" v="194" actId="1076"/>
          <ac:spMkLst>
            <pc:docMk/>
            <pc:sldMk cId="2722031128" sldId="262"/>
            <ac:spMk id="8" creationId="{6E7C8DA4-C0A2-071D-5242-99BC23628C4E}"/>
          </ac:spMkLst>
        </pc:spChg>
        <pc:spChg chg="add mod">
          <ac:chgData name="Severine Lamon" userId="ff329eb7-2761-407d-b01e-994c500efbc1" providerId="ADAL" clId="{95695FBC-71C7-4208-98E4-2EA2991D4161}" dt="2024-11-13T00:59:37.890" v="198" actId="20577"/>
          <ac:spMkLst>
            <pc:docMk/>
            <pc:sldMk cId="2722031128" sldId="262"/>
            <ac:spMk id="9" creationId="{A8B86651-FAEF-0E23-BD38-2A02B11417AB}"/>
          </ac:spMkLst>
        </pc:spChg>
        <pc:spChg chg="add mod">
          <ac:chgData name="Severine Lamon" userId="ff329eb7-2761-407d-b01e-994c500efbc1" providerId="ADAL" clId="{95695FBC-71C7-4208-98E4-2EA2991D4161}" dt="2024-11-13T00:59:48.609" v="201" actId="20577"/>
          <ac:spMkLst>
            <pc:docMk/>
            <pc:sldMk cId="2722031128" sldId="262"/>
            <ac:spMk id="10" creationId="{98EA6554-BCBD-80AE-9AF9-0CC9B8FD83DF}"/>
          </ac:spMkLst>
        </pc:spChg>
        <pc:picChg chg="add mod">
          <ac:chgData name="Severine Lamon" userId="ff329eb7-2761-407d-b01e-994c500efbc1" providerId="ADAL" clId="{95695FBC-71C7-4208-98E4-2EA2991D4161}" dt="2024-11-13T00:42:01.825" v="172" actId="1076"/>
          <ac:picMkLst>
            <pc:docMk/>
            <pc:sldMk cId="2722031128" sldId="262"/>
            <ac:picMk id="4" creationId="{E84B32C6-83E5-E229-DFB5-98C180464B61}"/>
          </ac:picMkLst>
        </pc:picChg>
        <pc:picChg chg="add mod">
          <ac:chgData name="Severine Lamon" userId="ff329eb7-2761-407d-b01e-994c500efbc1" providerId="ADAL" clId="{95695FBC-71C7-4208-98E4-2EA2991D4161}" dt="2024-11-13T00:41:53.646" v="169" actId="14100"/>
          <ac:picMkLst>
            <pc:docMk/>
            <pc:sldMk cId="2722031128" sldId="262"/>
            <ac:picMk id="6" creationId="{2FB157D0-A302-0242-DD39-C0EB36393C42}"/>
          </ac:picMkLst>
        </pc:picChg>
        <pc:picChg chg="add mod">
          <ac:chgData name="Severine Lamon" userId="ff329eb7-2761-407d-b01e-994c500efbc1" providerId="ADAL" clId="{95695FBC-71C7-4208-98E4-2EA2991D4161}" dt="2024-11-13T00:42:48.038" v="177" actId="1076"/>
          <ac:picMkLst>
            <pc:docMk/>
            <pc:sldMk cId="2722031128" sldId="262"/>
            <ac:picMk id="7" creationId="{37C7C5AB-C5EB-AC21-4459-D8D849B7E360}"/>
          </ac:picMkLst>
        </pc:picChg>
      </pc:sldChg>
      <pc:sldChg chg="modSp mod">
        <pc:chgData name="Severine Lamon" userId="ff329eb7-2761-407d-b01e-994c500efbc1" providerId="ADAL" clId="{95695FBC-71C7-4208-98E4-2EA2991D4161}" dt="2024-11-13T00:47:12.599" v="183" actId="20577"/>
        <pc:sldMkLst>
          <pc:docMk/>
          <pc:sldMk cId="650934161" sldId="263"/>
        </pc:sldMkLst>
        <pc:spChg chg="mod">
          <ac:chgData name="Severine Lamon" userId="ff329eb7-2761-407d-b01e-994c500efbc1" providerId="ADAL" clId="{95695FBC-71C7-4208-98E4-2EA2991D4161}" dt="2024-11-13T00:47:12.599" v="183" actId="20577"/>
          <ac:spMkLst>
            <pc:docMk/>
            <pc:sldMk cId="650934161" sldId="263"/>
            <ac:spMk id="3" creationId="{3363575A-31A0-5A6A-3AC5-7F20083CC554}"/>
          </ac:spMkLst>
        </pc:spChg>
      </pc:sldChg>
      <pc:sldChg chg="addSp delSp modSp mod">
        <pc:chgData name="Severine Lamon" userId="ff329eb7-2761-407d-b01e-994c500efbc1" providerId="ADAL" clId="{95695FBC-71C7-4208-98E4-2EA2991D4161}" dt="2024-11-13T01:15:36.834" v="250" actId="164"/>
        <pc:sldMkLst>
          <pc:docMk/>
          <pc:sldMk cId="1093224623" sldId="264"/>
        </pc:sldMkLst>
        <pc:spChg chg="mod">
          <ac:chgData name="Severine Lamon" userId="ff329eb7-2761-407d-b01e-994c500efbc1" providerId="ADAL" clId="{95695FBC-71C7-4208-98E4-2EA2991D4161}" dt="2024-11-13T00:47:57.201" v="184" actId="164"/>
          <ac:spMkLst>
            <pc:docMk/>
            <pc:sldMk cId="1093224623" sldId="264"/>
            <ac:spMk id="2" creationId="{6BDD324E-D2FF-CCF2-FD77-379DC566541C}"/>
          </ac:spMkLst>
        </pc:spChg>
        <pc:spChg chg="mod">
          <ac:chgData name="Severine Lamon" userId="ff329eb7-2761-407d-b01e-994c500efbc1" providerId="ADAL" clId="{95695FBC-71C7-4208-98E4-2EA2991D4161}" dt="2024-11-13T00:47:57.201" v="184" actId="164"/>
          <ac:spMkLst>
            <pc:docMk/>
            <pc:sldMk cId="1093224623" sldId="264"/>
            <ac:spMk id="3" creationId="{00B34F7E-F5CD-36FC-F9D2-4A3FE80F2718}"/>
          </ac:spMkLst>
        </pc:spChg>
        <pc:spChg chg="mod">
          <ac:chgData name="Severine Lamon" userId="ff329eb7-2761-407d-b01e-994c500efbc1" providerId="ADAL" clId="{95695FBC-71C7-4208-98E4-2EA2991D4161}" dt="2024-11-13T00:47:57.201" v="184" actId="164"/>
          <ac:spMkLst>
            <pc:docMk/>
            <pc:sldMk cId="1093224623" sldId="264"/>
            <ac:spMk id="5" creationId="{DEFED58C-18E1-40F0-50BD-AAE921CDC654}"/>
          </ac:spMkLst>
        </pc:spChg>
        <pc:spChg chg="add del mod">
          <ac:chgData name="Severine Lamon" userId="ff329eb7-2761-407d-b01e-994c500efbc1" providerId="ADAL" clId="{95695FBC-71C7-4208-98E4-2EA2991D4161}" dt="2024-11-13T01:13:40.369" v="230" actId="478"/>
          <ac:spMkLst>
            <pc:docMk/>
            <pc:sldMk cId="1093224623" sldId="264"/>
            <ac:spMk id="11" creationId="{65535154-BE23-09FF-F0E3-47D752A59BDE}"/>
          </ac:spMkLst>
        </pc:spChg>
        <pc:grpChg chg="add mod ord topLvl">
          <ac:chgData name="Severine Lamon" userId="ff329eb7-2761-407d-b01e-994c500efbc1" providerId="ADAL" clId="{95695FBC-71C7-4208-98E4-2EA2991D4161}" dt="2024-11-13T01:15:36.834" v="250" actId="164"/>
          <ac:grpSpMkLst>
            <pc:docMk/>
            <pc:sldMk cId="1093224623" sldId="264"/>
            <ac:grpSpMk id="8" creationId="{D62413E3-EE42-03CE-39B1-0FC9064541C1}"/>
          </ac:grpSpMkLst>
        </pc:grpChg>
        <pc:grpChg chg="add del mod">
          <ac:chgData name="Severine Lamon" userId="ff329eb7-2761-407d-b01e-994c500efbc1" providerId="ADAL" clId="{95695FBC-71C7-4208-98E4-2EA2991D4161}" dt="2024-11-13T01:13:36.302" v="228" actId="478"/>
          <ac:grpSpMkLst>
            <pc:docMk/>
            <pc:sldMk cId="1093224623" sldId="264"/>
            <ac:grpSpMk id="10" creationId="{C4920A86-7FEC-5E56-E240-4BB65112BA24}"/>
          </ac:grpSpMkLst>
        </pc:grpChg>
        <pc:grpChg chg="add mod">
          <ac:chgData name="Severine Lamon" userId="ff329eb7-2761-407d-b01e-994c500efbc1" providerId="ADAL" clId="{95695FBC-71C7-4208-98E4-2EA2991D4161}" dt="2024-11-13T01:15:36.834" v="250" actId="164"/>
          <ac:grpSpMkLst>
            <pc:docMk/>
            <pc:sldMk cId="1093224623" sldId="264"/>
            <ac:grpSpMk id="15" creationId="{B7F8FE1F-15E0-A374-5FEA-10E0407A3E8C}"/>
          </ac:grpSpMkLst>
        </pc:grpChg>
        <pc:picChg chg="mod">
          <ac:chgData name="Severine Lamon" userId="ff329eb7-2761-407d-b01e-994c500efbc1" providerId="ADAL" clId="{95695FBC-71C7-4208-98E4-2EA2991D4161}" dt="2024-11-13T00:47:57.201" v="184" actId="164"/>
          <ac:picMkLst>
            <pc:docMk/>
            <pc:sldMk cId="1093224623" sldId="264"/>
            <ac:picMk id="4" creationId="{EDA647B8-42B8-C557-796A-04583191F6B1}"/>
          </ac:picMkLst>
        </pc:picChg>
        <pc:picChg chg="add del mod ord">
          <ac:chgData name="Severine Lamon" userId="ff329eb7-2761-407d-b01e-994c500efbc1" providerId="ADAL" clId="{95695FBC-71C7-4208-98E4-2EA2991D4161}" dt="2024-11-13T00:47:57.201" v="184" actId="164"/>
          <ac:picMkLst>
            <pc:docMk/>
            <pc:sldMk cId="1093224623" sldId="264"/>
            <ac:picMk id="6" creationId="{915C7D0B-2229-8994-1A49-39603F9B06CF}"/>
          </ac:picMkLst>
        </pc:picChg>
        <pc:picChg chg="add mod ord">
          <ac:chgData name="Severine Lamon" userId="ff329eb7-2761-407d-b01e-994c500efbc1" providerId="ADAL" clId="{95695FBC-71C7-4208-98E4-2EA2991D4161}" dt="2024-11-11T07:33:30.154" v="10" actId="14100"/>
          <ac:picMkLst>
            <pc:docMk/>
            <pc:sldMk cId="1093224623" sldId="264"/>
            <ac:picMk id="8" creationId="{90871AAE-4672-9811-ABED-A1424D0B7EB1}"/>
          </ac:picMkLst>
        </pc:picChg>
        <pc:picChg chg="add del mod ord topLvl modCrop">
          <ac:chgData name="Severine Lamon" userId="ff329eb7-2761-407d-b01e-994c500efbc1" providerId="ADAL" clId="{95695FBC-71C7-4208-98E4-2EA2991D4161}" dt="2024-11-13T01:13:36.302" v="228" actId="478"/>
          <ac:picMkLst>
            <pc:docMk/>
            <pc:sldMk cId="1093224623" sldId="264"/>
            <ac:picMk id="9" creationId="{D3E4179A-5BCA-15F9-EEB5-467742AA8652}"/>
          </ac:picMkLst>
        </pc:picChg>
        <pc:picChg chg="add del mod">
          <ac:chgData name="Severine Lamon" userId="ff329eb7-2761-407d-b01e-994c500efbc1" providerId="ADAL" clId="{95695FBC-71C7-4208-98E4-2EA2991D4161}" dt="2024-11-13T01:07:02.383" v="205" actId="478"/>
          <ac:picMkLst>
            <pc:docMk/>
            <pc:sldMk cId="1093224623" sldId="264"/>
            <ac:picMk id="12" creationId="{604958FA-DDC5-CD1F-5F6A-74CCF16DAA8A}"/>
          </ac:picMkLst>
        </pc:picChg>
        <pc:picChg chg="add mod modCrop">
          <ac:chgData name="Severine Lamon" userId="ff329eb7-2761-407d-b01e-994c500efbc1" providerId="ADAL" clId="{95695FBC-71C7-4208-98E4-2EA2991D4161}" dt="2024-11-13T01:15:36.834" v="250" actId="164"/>
          <ac:picMkLst>
            <pc:docMk/>
            <pc:sldMk cId="1093224623" sldId="264"/>
            <ac:picMk id="14" creationId="{51F44219-7277-F943-74F0-A2313232FB14}"/>
          </ac:picMkLst>
        </pc:picChg>
      </pc:sldChg>
      <pc:sldChg chg="del">
        <pc:chgData name="Severine Lamon" userId="ff329eb7-2761-407d-b01e-994c500efbc1" providerId="ADAL" clId="{95695FBC-71C7-4208-98E4-2EA2991D4161}" dt="2024-11-11T07:35:57.356" v="34" actId="47"/>
        <pc:sldMkLst>
          <pc:docMk/>
          <pc:sldMk cId="488618507" sldId="265"/>
        </pc:sldMkLst>
      </pc:sldChg>
      <pc:sldChg chg="addSp delSp modSp add mod">
        <pc:chgData name="Severine Lamon" userId="ff329eb7-2761-407d-b01e-994c500efbc1" providerId="ADAL" clId="{95695FBC-71C7-4208-98E4-2EA2991D4161}" dt="2024-11-13T01:15:30.480" v="249" actId="732"/>
        <pc:sldMkLst>
          <pc:docMk/>
          <pc:sldMk cId="3741975043" sldId="266"/>
        </pc:sldMkLst>
        <pc:spChg chg="mod">
          <ac:chgData name="Severine Lamon" userId="ff329eb7-2761-407d-b01e-994c500efbc1" providerId="ADAL" clId="{95695FBC-71C7-4208-98E4-2EA2991D4161}" dt="2024-11-13T00:56:17.959" v="190" actId="164"/>
          <ac:spMkLst>
            <pc:docMk/>
            <pc:sldMk cId="3741975043" sldId="266"/>
            <ac:spMk id="2" creationId="{4ECC25D2-C01B-E097-DB28-D7662750A913}"/>
          </ac:spMkLst>
        </pc:spChg>
        <pc:spChg chg="mod">
          <ac:chgData name="Severine Lamon" userId="ff329eb7-2761-407d-b01e-994c500efbc1" providerId="ADAL" clId="{95695FBC-71C7-4208-98E4-2EA2991D4161}" dt="2024-11-13T01:15:17.684" v="247" actId="1076"/>
          <ac:spMkLst>
            <pc:docMk/>
            <pc:sldMk cId="3741975043" sldId="266"/>
            <ac:spMk id="3" creationId="{34767967-3B52-0D67-6AED-ECF9138C8838}"/>
          </ac:spMkLst>
        </pc:spChg>
        <pc:spChg chg="mod">
          <ac:chgData name="Severine Lamon" userId="ff329eb7-2761-407d-b01e-994c500efbc1" providerId="ADAL" clId="{95695FBC-71C7-4208-98E4-2EA2991D4161}" dt="2024-11-13T00:56:17.959" v="190" actId="164"/>
          <ac:spMkLst>
            <pc:docMk/>
            <pc:sldMk cId="3741975043" sldId="266"/>
            <ac:spMk id="5" creationId="{6FAC473A-E25B-B79E-B9B8-4EE1FC26AC35}"/>
          </ac:spMkLst>
        </pc:spChg>
        <pc:spChg chg="mod">
          <ac:chgData name="Severine Lamon" userId="ff329eb7-2761-407d-b01e-994c500efbc1" providerId="ADAL" clId="{95695FBC-71C7-4208-98E4-2EA2991D4161}" dt="2024-11-11T07:32:55.929" v="2" actId="20577"/>
          <ac:spMkLst>
            <pc:docMk/>
            <pc:sldMk cId="3741975043" sldId="266"/>
            <ac:spMk id="7" creationId="{966980C3-3EAC-B3A3-437F-4BD461E76892}"/>
          </ac:spMkLst>
        </pc:spChg>
        <pc:grpChg chg="add mod">
          <ac:chgData name="Severine Lamon" userId="ff329eb7-2761-407d-b01e-994c500efbc1" providerId="ADAL" clId="{95695FBC-71C7-4208-98E4-2EA2991D4161}" dt="2024-11-13T00:56:17.959" v="190" actId="164"/>
          <ac:grpSpMkLst>
            <pc:docMk/>
            <pc:sldMk cId="3741975043" sldId="266"/>
            <ac:grpSpMk id="4" creationId="{59CC5A0A-C577-44B7-66AD-58336B28628F}"/>
          </ac:grpSpMkLst>
        </pc:grpChg>
        <pc:picChg chg="del">
          <ac:chgData name="Severine Lamon" userId="ff329eb7-2761-407d-b01e-994c500efbc1" providerId="ADAL" clId="{95695FBC-71C7-4208-98E4-2EA2991D4161}" dt="2024-11-11T07:35:39.973" v="30" actId="478"/>
          <ac:picMkLst>
            <pc:docMk/>
            <pc:sldMk cId="3741975043" sldId="266"/>
            <ac:picMk id="4" creationId="{2E33DF61-4B77-B812-E362-33FA0BBA9169}"/>
          </ac:picMkLst>
        </pc:picChg>
        <pc:picChg chg="del">
          <ac:chgData name="Severine Lamon" userId="ff329eb7-2761-407d-b01e-994c500efbc1" providerId="ADAL" clId="{95695FBC-71C7-4208-98E4-2EA2991D4161}" dt="2024-11-11T07:34:12.517" v="21" actId="478"/>
          <ac:picMkLst>
            <pc:docMk/>
            <pc:sldMk cId="3741975043" sldId="266"/>
            <ac:picMk id="6" creationId="{BDA3100E-0992-DCBB-0B9A-6EF82C869D4A}"/>
          </ac:picMkLst>
        </pc:picChg>
        <pc:picChg chg="add del mod ord">
          <ac:chgData name="Severine Lamon" userId="ff329eb7-2761-407d-b01e-994c500efbc1" providerId="ADAL" clId="{95695FBC-71C7-4208-98E4-2EA2991D4161}" dt="2024-11-13T01:14:35.629" v="240" actId="478"/>
          <ac:picMkLst>
            <pc:docMk/>
            <pc:sldMk cId="3741975043" sldId="266"/>
            <ac:picMk id="8" creationId="{B5A6C325-D49C-028D-8A25-6221E619D16D}"/>
          </ac:picMkLst>
        </pc:picChg>
        <pc:picChg chg="add mod ord">
          <ac:chgData name="Severine Lamon" userId="ff329eb7-2761-407d-b01e-994c500efbc1" providerId="ADAL" clId="{95695FBC-71C7-4208-98E4-2EA2991D4161}" dt="2024-11-13T00:56:17.959" v="190" actId="164"/>
          <ac:picMkLst>
            <pc:docMk/>
            <pc:sldMk cId="3741975043" sldId="266"/>
            <ac:picMk id="9" creationId="{7227194E-15C1-A00E-BE8C-C954DD0B9F35}"/>
          </ac:picMkLst>
        </pc:picChg>
        <pc:picChg chg="add mod ord">
          <ac:chgData name="Severine Lamon" userId="ff329eb7-2761-407d-b01e-994c500efbc1" providerId="ADAL" clId="{95695FBC-71C7-4208-98E4-2EA2991D4161}" dt="2024-11-13T00:56:17.959" v="190" actId="164"/>
          <ac:picMkLst>
            <pc:docMk/>
            <pc:sldMk cId="3741975043" sldId="266"/>
            <ac:picMk id="10" creationId="{0A99F857-1A52-3299-0B2E-8C6B7A0895E5}"/>
          </ac:picMkLst>
        </pc:picChg>
        <pc:picChg chg="add mod modCrop">
          <ac:chgData name="Severine Lamon" userId="ff329eb7-2761-407d-b01e-994c500efbc1" providerId="ADAL" clId="{95695FBC-71C7-4208-98E4-2EA2991D4161}" dt="2024-11-13T01:15:30.480" v="249" actId="732"/>
          <ac:picMkLst>
            <pc:docMk/>
            <pc:sldMk cId="3741975043" sldId="266"/>
            <ac:picMk id="11" creationId="{39ED257F-054A-4D08-C863-3F1B6DA4A21A}"/>
          </ac:picMkLst>
        </pc:picChg>
        <pc:picChg chg="del">
          <ac:chgData name="Severine Lamon" userId="ff329eb7-2761-407d-b01e-994c500efbc1" providerId="ADAL" clId="{95695FBC-71C7-4208-98E4-2EA2991D4161}" dt="2024-11-11T07:33:36.373" v="12" actId="478"/>
          <ac:picMkLst>
            <pc:docMk/>
            <pc:sldMk cId="3741975043" sldId="266"/>
            <ac:picMk id="12" creationId="{E4BCF889-B3FD-1A34-B71A-5829F26CC47D}"/>
          </ac:picMkLst>
        </pc:picChg>
      </pc:sldChg>
      <pc:sldChg chg="addSp modSp new mod">
        <pc:chgData name="Severine Lamon" userId="ff329eb7-2761-407d-b01e-994c500efbc1" providerId="ADAL" clId="{95695FBC-71C7-4208-98E4-2EA2991D4161}" dt="2024-11-13T01:12:12.250" v="227" actId="113"/>
        <pc:sldMkLst>
          <pc:docMk/>
          <pc:sldMk cId="2198440977" sldId="267"/>
        </pc:sldMkLst>
        <pc:spChg chg="add mod">
          <ac:chgData name="Severine Lamon" userId="ff329eb7-2761-407d-b01e-994c500efbc1" providerId="ADAL" clId="{95695FBC-71C7-4208-98E4-2EA2991D4161}" dt="2024-11-13T00:34:57.263" v="134"/>
          <ac:spMkLst>
            <pc:docMk/>
            <pc:sldMk cId="2198440977" sldId="267"/>
            <ac:spMk id="3" creationId="{3363575A-31A0-5A6A-3AC5-7F20083CC554}"/>
          </ac:spMkLst>
        </pc:spChg>
        <pc:spChg chg="add mod">
          <ac:chgData name="Severine Lamon" userId="ff329eb7-2761-407d-b01e-994c500efbc1" providerId="ADAL" clId="{95695FBC-71C7-4208-98E4-2EA2991D4161}" dt="2024-11-13T00:38:58.235" v="135" actId="1076"/>
          <ac:spMkLst>
            <pc:docMk/>
            <pc:sldMk cId="2198440977" sldId="267"/>
            <ac:spMk id="5" creationId="{FB450F13-A767-39C9-0B2E-5D0F8363A377}"/>
          </ac:spMkLst>
        </pc:spChg>
        <pc:spChg chg="add mod">
          <ac:chgData name="Severine Lamon" userId="ff329eb7-2761-407d-b01e-994c500efbc1" providerId="ADAL" clId="{95695FBC-71C7-4208-98E4-2EA2991D4161}" dt="2024-11-13T01:04:44.543" v="203" actId="1076"/>
          <ac:spMkLst>
            <pc:docMk/>
            <pc:sldMk cId="2198440977" sldId="267"/>
            <ac:spMk id="7" creationId="{0D031C5C-911D-38CC-49C0-B8C497126143}"/>
          </ac:spMkLst>
        </pc:spChg>
        <pc:spChg chg="add mod">
          <ac:chgData name="Severine Lamon" userId="ff329eb7-2761-407d-b01e-994c500efbc1" providerId="ADAL" clId="{95695FBC-71C7-4208-98E4-2EA2991D4161}" dt="2024-11-13T01:12:12.250" v="227" actId="113"/>
          <ac:spMkLst>
            <pc:docMk/>
            <pc:sldMk cId="2198440977" sldId="267"/>
            <ac:spMk id="8" creationId="{6BE6FA05-B222-5964-30AD-F1918BD2DA2D}"/>
          </ac:spMkLst>
        </pc:spChg>
        <pc:picChg chg="add mod">
          <ac:chgData name="Severine Lamon" userId="ff329eb7-2761-407d-b01e-994c500efbc1" providerId="ADAL" clId="{95695FBC-71C7-4208-98E4-2EA2991D4161}" dt="2024-11-13T01:11:52.686" v="215" actId="1076"/>
          <ac:picMkLst>
            <pc:docMk/>
            <pc:sldMk cId="2198440977" sldId="267"/>
            <ac:picMk id="4" creationId="{9B198ABB-9B98-1AB1-7DD9-507FF6DF5D91}"/>
          </ac:picMkLst>
        </pc:picChg>
      </pc:sldChg>
      <pc:sldChg chg="addSp delSp modSp add mod">
        <pc:chgData name="Severine Lamon" userId="ff329eb7-2761-407d-b01e-994c500efbc1" providerId="ADAL" clId="{95695FBC-71C7-4208-98E4-2EA2991D4161}" dt="2024-11-13T01:07:48.813" v="212" actId="1076"/>
        <pc:sldMkLst>
          <pc:docMk/>
          <pc:sldMk cId="2308238486" sldId="268"/>
        </pc:sldMkLst>
        <pc:spChg chg="mod">
          <ac:chgData name="Severine Lamon" userId="ff329eb7-2761-407d-b01e-994c500efbc1" providerId="ADAL" clId="{95695FBC-71C7-4208-98E4-2EA2991D4161}" dt="2024-11-13T00:50:58.071" v="187" actId="20577"/>
          <ac:spMkLst>
            <pc:docMk/>
            <pc:sldMk cId="2308238486" sldId="268"/>
            <ac:spMk id="3" creationId="{2FD3199B-3809-5C3B-9859-E69E47ECB6AE}"/>
          </ac:spMkLst>
        </pc:spChg>
        <pc:spChg chg="add mod">
          <ac:chgData name="Severine Lamon" userId="ff329eb7-2761-407d-b01e-994c500efbc1" providerId="ADAL" clId="{95695FBC-71C7-4208-98E4-2EA2991D4161}" dt="2024-11-13T01:07:48.813" v="212" actId="1076"/>
          <ac:spMkLst>
            <pc:docMk/>
            <pc:sldMk cId="2308238486" sldId="268"/>
            <ac:spMk id="4" creationId="{5D6ED50C-425D-0ACF-EF8D-7A61326D8EAB}"/>
          </ac:spMkLst>
        </pc:spChg>
        <pc:picChg chg="del">
          <ac:chgData name="Severine Lamon" userId="ff329eb7-2761-407d-b01e-994c500efbc1" providerId="ADAL" clId="{95695FBC-71C7-4208-98E4-2EA2991D4161}" dt="2024-11-13T00:50:59.301" v="188" actId="478"/>
          <ac:picMkLst>
            <pc:docMk/>
            <pc:sldMk cId="2308238486" sldId="268"/>
            <ac:picMk id="8" creationId="{388A1C53-38A0-F34A-7C68-77A019535BF8}"/>
          </ac:picMkLst>
        </pc:picChg>
        <pc:picChg chg="del">
          <ac:chgData name="Severine Lamon" userId="ff329eb7-2761-407d-b01e-994c500efbc1" providerId="ADAL" clId="{95695FBC-71C7-4208-98E4-2EA2991D4161}" dt="2024-11-13T00:50:59.652" v="189" actId="478"/>
          <ac:picMkLst>
            <pc:docMk/>
            <pc:sldMk cId="2308238486" sldId="268"/>
            <ac:picMk id="10" creationId="{2356C292-D523-F9BD-4AC0-648868AE92C2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0F0194F-8EC8-4007-9D06-8E97087090C2}" type="datetimeFigureOut">
              <a:rPr lang="en-AU" smtClean="0"/>
              <a:t>26/06/2025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CE712DD-5F80-4F6C-B281-0458F1B90A5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71004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CE712DD-5F80-4F6C-B281-0458F1B90A55}" type="slidenum">
              <a:rPr lang="en-AU" smtClean="0"/>
              <a:t>7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6899183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CE712DD-5F80-4F6C-B281-0458F1B90A55}" type="slidenum">
              <a:rPr lang="en-AU" smtClean="0"/>
              <a:t>8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0941909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CE3BC88-4F30-3A37-8AD2-31A150C2BAF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59A32F05-7FF2-37F3-B4B5-B373E97867B5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5C009591-B57E-0CD2-18BC-D14D63064B06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F5AF89F-F89B-4EEE-BC88-B45783D75E8A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CE712DD-5F80-4F6C-B281-0458F1B90A55}" type="slidenum">
              <a:rPr lang="en-AU" smtClean="0"/>
              <a:t>9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8980015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731B4EE-2746-5150-33C1-B29221FC708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24917DD7-C7B1-9E55-1DE6-5F3C78E332FE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824FF297-7180-D189-C715-DC0110A2ECB4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63738F6-8B12-3F71-EBE0-C5F397A810A0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CE712DD-5F80-4F6C-B281-0458F1B90A55}" type="slidenum">
              <a:rPr lang="en-AU" smtClean="0"/>
              <a:t>10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886720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5DF4C8-AFD4-5155-F8DB-0CA77AA27C7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E35148A-81C3-4AC0-AE05-A0408188D7C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EE9E57-504B-293E-273E-F066354996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F28F2-7300-4A85-879B-CCA2C39835B1}" type="datetimeFigureOut">
              <a:rPr lang="en-AU" smtClean="0"/>
              <a:t>26/06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0DFC44-853D-76E5-3B25-D261FC3D93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E141F7-65FE-9539-5481-A911A97843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52C7B8-8668-44C4-88C0-F7C6B6DAA1F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976244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1BAB92-C9E4-1E58-61D7-42A96DC1CC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1EF9793-33B0-89D1-F566-01A61610071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FC18B0-F7F1-E4DF-349E-A718FF4A2A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F28F2-7300-4A85-879B-CCA2C39835B1}" type="datetimeFigureOut">
              <a:rPr lang="en-AU" smtClean="0"/>
              <a:t>26/06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FB7648-3482-AB14-30EA-BB29D138B6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F56CE0-0FBE-5993-2B16-71EE005F5D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52C7B8-8668-44C4-88C0-F7C6B6DAA1F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942059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B45CF67-B071-A5F3-844A-FBED475E6E6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101BC8F-50C4-C294-5D5E-CCF5DA80647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D0C6B5-2121-3D87-2E3F-E0D78F1E28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F28F2-7300-4A85-879B-CCA2C39835B1}" type="datetimeFigureOut">
              <a:rPr lang="en-AU" smtClean="0"/>
              <a:t>26/06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6C3BE9-0D60-3434-E0C2-1F5DB94A09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DAFF9D-BEE9-786F-E131-D6247D7383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52C7B8-8668-44C4-88C0-F7C6B6DAA1F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142090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6E7111-6E3C-E92D-2651-CAA72DAA94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90D6C57-F1DC-B574-9720-A966D7B7671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434CC5-749E-3915-5655-886F177577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F28F2-7300-4A85-879B-CCA2C39835B1}" type="datetimeFigureOut">
              <a:rPr lang="en-AU" smtClean="0"/>
              <a:t>26/06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D9DF86-CB62-5D1B-73B8-92FEAD8B31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658A76-ACA0-7503-8450-43A42803EF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52C7B8-8668-44C4-88C0-F7C6B6DAA1F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143981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C48788-FE3D-31F9-1F47-4E24A32920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FC706DD-F3D1-2DD2-7CCF-706E0D9545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5F2824-FD3C-2A78-00C4-8E6AC584C3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F28F2-7300-4A85-879B-CCA2C39835B1}" type="datetimeFigureOut">
              <a:rPr lang="en-AU" smtClean="0"/>
              <a:t>26/06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799B02-FB70-581E-DC80-4A15DD5B66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1DC4A9-6248-EB29-75B4-AC6203C0DF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52C7B8-8668-44C4-88C0-F7C6B6DAA1F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570247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E0803E-EBFB-417B-DBAA-D71BEBED90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C36C3C-E7E0-6FDE-773B-DFFF1445324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32BDD2-ECBD-EF7B-A4CE-6F6963B4620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3E84BFD-52FC-A06E-A052-F860729E3D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F28F2-7300-4A85-879B-CCA2C39835B1}" type="datetimeFigureOut">
              <a:rPr lang="en-AU" smtClean="0"/>
              <a:t>26/06/2025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7052D26-E552-F4AE-9655-89F7F7806F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DBFF80A-EEA2-ABB7-0345-DB16ED89AF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52C7B8-8668-44C4-88C0-F7C6B6DAA1F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36173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2EDD6A-55E5-1809-A1E0-BC3CE17D67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81243D1-109C-919A-54ED-C93C613941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F1A9259-6071-1067-D2FF-455B53023D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24FE629-4EE3-B227-AFF9-9F009348D57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DA5EF6F-543B-81B7-A2A5-577B6073C9C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EEC8A3B-0164-9F95-EA06-B80F0F7966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F28F2-7300-4A85-879B-CCA2C39835B1}" type="datetimeFigureOut">
              <a:rPr lang="en-AU" smtClean="0"/>
              <a:t>26/06/2025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E34E805-3F0D-BF02-425D-CFD32D59C2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1DF6568-3BAB-2A50-4209-4415702C8C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52C7B8-8668-44C4-88C0-F7C6B6DAA1F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23369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5C0CB6-52F6-7A4E-5AC4-9AA9C14A3B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C19E52F-BE88-4C74-44A6-56B09A848C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F28F2-7300-4A85-879B-CCA2C39835B1}" type="datetimeFigureOut">
              <a:rPr lang="en-AU" smtClean="0"/>
              <a:t>26/06/2025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5A563F5-2CB4-0176-9940-68E2D1A659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05BA68B-7178-A3BA-C97D-1D1419156F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52C7B8-8668-44C4-88C0-F7C6B6DAA1F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792608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23521D6-373C-10CF-9EE8-C679656158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F28F2-7300-4A85-879B-CCA2C39835B1}" type="datetimeFigureOut">
              <a:rPr lang="en-AU" smtClean="0"/>
              <a:t>26/06/2025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9BE9E5C-B3F3-01AF-12BB-37B7DD334E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03D6650-8516-3BB1-37BA-1F511B3BB0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52C7B8-8668-44C4-88C0-F7C6B6DAA1F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242892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D0501A-A929-9A51-A172-908CDDE21C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7C4EB4-695D-3295-4C03-C10951003C6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7A003E1-AE89-6BB2-99BB-4B280F3F357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C9F0BD2-28E1-28C2-B702-4A8B533DCA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F28F2-7300-4A85-879B-CCA2C39835B1}" type="datetimeFigureOut">
              <a:rPr lang="en-AU" smtClean="0"/>
              <a:t>26/06/2025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7EE37B9-F5ED-E581-47F4-1B8CAAB7EB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BE81C27-924C-02A2-9164-F5520E862E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52C7B8-8668-44C4-88C0-F7C6B6DAA1F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575015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DF44C6-99FF-C30D-8774-6FFA635573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67B1E75-0B19-9F3E-5DD8-8A32FB76B85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84779B4-3D4B-E48D-6528-8570F500D87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BE8B0A-72A2-E572-1B3B-330CB3ACA0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F28F2-7300-4A85-879B-CCA2C39835B1}" type="datetimeFigureOut">
              <a:rPr lang="en-AU" smtClean="0"/>
              <a:t>26/06/2025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10F1F0-AA1E-F685-27DE-A712103254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B2600F2-DAF9-DDA4-F668-7E3245E55B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52C7B8-8668-44C4-88C0-F7C6B6DAA1F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362308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DD92268-43D4-133F-99AD-738C2517F3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FA4CE1-8294-E610-FD77-FA6E1C6817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C0155F-FAB0-3A1F-42E8-42542296161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0FF28F2-7300-4A85-879B-CCA2C39835B1}" type="datetimeFigureOut">
              <a:rPr lang="en-AU" smtClean="0"/>
              <a:t>26/06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D77A4E-B78B-23C7-5080-7E2781F350E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B3246E-12BC-1E8C-2633-A350C11B73F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A52C7B8-8668-44C4-88C0-F7C6B6DAA1F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969904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4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5.png"/><Relationship Id="rId4" Type="http://schemas.openxmlformats.org/officeDocument/2006/relationships/image" Target="../media/image2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F1A5BA-BFC1-131B-4BFF-74C417971766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AU" sz="1800" b="1" i="0" dirty="0">
                <a:solidFill>
                  <a:srgbClr val="000000"/>
                </a:solidFill>
                <a:effectLst/>
                <a:latin typeface="Aptos" panose="020B0004020202020204" pitchFamily="34" charset="0"/>
              </a:rPr>
              <a:t>The transcriptomic signature of age and sex is not conserved in human primary myocytes</a:t>
            </a:r>
            <a:r>
              <a:rPr lang="en-AU" sz="1800" b="0" i="0" dirty="0">
                <a:solidFill>
                  <a:srgbClr val="000000"/>
                </a:solidFill>
                <a:effectLst/>
                <a:latin typeface="Aptos" panose="020B0004020202020204" pitchFamily="34" charset="0"/>
              </a:rPr>
              <a:t> </a:t>
            </a:r>
            <a:br>
              <a:rPr lang="en-AU" sz="1800" b="0" i="0" dirty="0">
                <a:solidFill>
                  <a:srgbClr val="000000"/>
                </a:solidFill>
                <a:effectLst/>
                <a:latin typeface="Aptos" panose="020B0004020202020204" pitchFamily="34" charset="0"/>
              </a:rPr>
            </a:br>
            <a:br>
              <a:rPr lang="en-AU" sz="1800" b="0" i="0" dirty="0">
                <a:solidFill>
                  <a:srgbClr val="000000"/>
                </a:solidFill>
                <a:effectLst/>
                <a:latin typeface="Aptos" panose="020B0004020202020204" pitchFamily="34" charset="0"/>
              </a:rPr>
            </a:br>
            <a:r>
              <a:rPr lang="en-AU" sz="1800" b="0" i="0" dirty="0">
                <a:solidFill>
                  <a:srgbClr val="000000"/>
                </a:solidFill>
                <a:effectLst/>
                <a:latin typeface="Aptos" panose="020B0004020202020204" pitchFamily="34" charset="0"/>
              </a:rPr>
              <a:t>Lamon S. et al.</a:t>
            </a:r>
            <a:endParaRPr lang="en-AU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75CB21E-98D7-D2B0-6FC9-7168FCADA16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4163438"/>
            <a:ext cx="9144000" cy="1094362"/>
          </a:xfrm>
        </p:spPr>
        <p:txBody>
          <a:bodyPr/>
          <a:lstStyle/>
          <a:p>
            <a:r>
              <a:rPr lang="en-AU" dirty="0"/>
              <a:t>Supplementary Figures</a:t>
            </a:r>
          </a:p>
        </p:txBody>
      </p:sp>
    </p:spTree>
    <p:extLst>
      <p:ext uri="{BB962C8B-B14F-4D97-AF65-F5344CB8AC3E}">
        <p14:creationId xmlns:p14="http://schemas.microsoft.com/office/powerpoint/2010/main" val="214594620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9F5F915-0ED6-65BD-7623-867F4B20D97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96B3A99D-280D-3CDC-323B-C0E17714B0DE}"/>
              </a:ext>
            </a:extLst>
          </p:cNvPr>
          <p:cNvSpPr txBox="1"/>
          <p:nvPr/>
        </p:nvSpPr>
        <p:spPr>
          <a:xfrm>
            <a:off x="262890" y="247888"/>
            <a:ext cx="31832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Supplementary Figure 4 (4/4)</a:t>
            </a:r>
          </a:p>
        </p:txBody>
      </p:sp>
      <p:pic>
        <p:nvPicPr>
          <p:cNvPr id="6" name="Picture 5" descr="A graph of a number of different colored squares&#10;&#10;Description automatically generated with medium confidence">
            <a:extLst>
              <a:ext uri="{FF2B5EF4-FFF2-40B4-BE49-F238E27FC236}">
                <a16:creationId xmlns:a16="http://schemas.microsoft.com/office/drawing/2014/main" id="{F7BEEB0E-008E-D4E7-C446-42C520401A3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890" y="1401197"/>
            <a:ext cx="4068701" cy="47867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1642465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8590897-7088-DAA3-2B44-F78AA331863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466F5A7A-672D-6647-96CE-EB1B1379B15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31670" y="1287780"/>
            <a:ext cx="7924800" cy="4953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C8C00C6-6901-AD7D-6D41-ED37A096D5D9}"/>
              </a:ext>
            </a:extLst>
          </p:cNvPr>
          <p:cNvSpPr txBox="1"/>
          <p:nvPr/>
        </p:nvSpPr>
        <p:spPr>
          <a:xfrm>
            <a:off x="262890" y="247888"/>
            <a:ext cx="2665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Supplementary Figure 5</a:t>
            </a:r>
          </a:p>
        </p:txBody>
      </p:sp>
    </p:spTree>
    <p:extLst>
      <p:ext uri="{BB962C8B-B14F-4D97-AF65-F5344CB8AC3E}">
        <p14:creationId xmlns:p14="http://schemas.microsoft.com/office/powerpoint/2010/main" val="356155460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3363575A-31A0-5A6A-3AC5-7F20083CC554}"/>
              </a:ext>
            </a:extLst>
          </p:cNvPr>
          <p:cNvSpPr txBox="1"/>
          <p:nvPr/>
        </p:nvSpPr>
        <p:spPr>
          <a:xfrm>
            <a:off x="262890" y="247888"/>
            <a:ext cx="2665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Supplementary Figure 6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D40D9AC-B9DE-B529-833A-7992ABA504F8}"/>
              </a:ext>
            </a:extLst>
          </p:cNvPr>
          <p:cNvSpPr txBox="1"/>
          <p:nvPr/>
        </p:nvSpPr>
        <p:spPr>
          <a:xfrm>
            <a:off x="277884" y="874395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592BDEE-2C83-3527-BFCE-FDB01F5BB006}"/>
              </a:ext>
            </a:extLst>
          </p:cNvPr>
          <p:cNvSpPr txBox="1"/>
          <p:nvPr/>
        </p:nvSpPr>
        <p:spPr>
          <a:xfrm>
            <a:off x="5876155" y="899748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/>
              <a:t>B</a:t>
            </a:r>
          </a:p>
        </p:txBody>
      </p:sp>
      <p:pic>
        <p:nvPicPr>
          <p:cNvPr id="8" name="Picture 7" descr="A diagram of different colored dots&#10;&#10;Description automatically generated">
            <a:extLst>
              <a:ext uri="{FF2B5EF4-FFF2-40B4-BE49-F238E27FC236}">
                <a16:creationId xmlns:a16="http://schemas.microsoft.com/office/drawing/2014/main" id="{EF7C240A-E145-EB76-3FFD-9ED7C75057B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890" y="1269080"/>
            <a:ext cx="5143500" cy="2857500"/>
          </a:xfrm>
          <a:prstGeom prst="rect">
            <a:avLst/>
          </a:prstGeom>
        </p:spPr>
      </p:pic>
      <p:pic>
        <p:nvPicPr>
          <p:cNvPr id="10" name="Picture 9" descr="A diagram of different colored dots&#10;&#10;Description automatically generated">
            <a:extLst>
              <a:ext uri="{FF2B5EF4-FFF2-40B4-BE49-F238E27FC236}">
                <a16:creationId xmlns:a16="http://schemas.microsoft.com/office/drawing/2014/main" id="{766526D8-3279-89F3-D2C6-4AF8A79C061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18699" y="1269080"/>
            <a:ext cx="5143500" cy="2857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509341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6DBB76F-1CAA-85F6-947E-B738C5120C3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4D7BA47-5ABA-F26B-4296-8324B519E2D8}"/>
              </a:ext>
            </a:extLst>
          </p:cNvPr>
          <p:cNvSpPr txBox="1"/>
          <p:nvPr/>
        </p:nvSpPr>
        <p:spPr>
          <a:xfrm>
            <a:off x="262890" y="247888"/>
            <a:ext cx="26558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Supplementary Figure 1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00928FFD-568E-0188-16AF-22B0BB21C420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t="15033" b="1"/>
          <a:stretch>
            <a:fillRect/>
          </a:stretch>
        </p:blipFill>
        <p:spPr>
          <a:xfrm>
            <a:off x="1221812" y="1692203"/>
            <a:ext cx="8836588" cy="4917909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E8D2C37-B363-1D2D-20CE-994E41334921}"/>
              </a:ext>
            </a:extLst>
          </p:cNvPr>
          <p:cNvSpPr txBox="1"/>
          <p:nvPr/>
        </p:nvSpPr>
        <p:spPr>
          <a:xfrm>
            <a:off x="3438144" y="819170"/>
            <a:ext cx="355514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Tissue (all samples) PCA plot</a:t>
            </a:r>
            <a:endParaRPr lang="en-AU" sz="2000" b="1" dirty="0"/>
          </a:p>
        </p:txBody>
      </p:sp>
    </p:spTree>
    <p:extLst>
      <p:ext uri="{BB962C8B-B14F-4D97-AF65-F5344CB8AC3E}">
        <p14:creationId xmlns:p14="http://schemas.microsoft.com/office/powerpoint/2010/main" val="14098851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cells and a graph&#10;&#10;AI-generated content may be incorrect.">
            <a:extLst>
              <a:ext uri="{FF2B5EF4-FFF2-40B4-BE49-F238E27FC236}">
                <a16:creationId xmlns:a16="http://schemas.microsoft.com/office/drawing/2014/main" id="{E30D6C32-A6D6-8065-D76D-A42C7BE8695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443"/>
          <a:stretch>
            <a:fillRect/>
          </a:stretch>
        </p:blipFill>
        <p:spPr>
          <a:xfrm>
            <a:off x="405385" y="2676051"/>
            <a:ext cx="6196584" cy="323697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2B798A1-71E1-1A17-9C4F-2C08C0F09A74}"/>
              </a:ext>
            </a:extLst>
          </p:cNvPr>
          <p:cNvSpPr txBox="1"/>
          <p:nvPr/>
        </p:nvSpPr>
        <p:spPr>
          <a:xfrm>
            <a:off x="262890" y="247888"/>
            <a:ext cx="26558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Supplementary Figure 2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882D0AE1-F38C-E43F-35D1-0B5C1CFBAF9C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13012" t="6544" r="15076"/>
          <a:stretch>
            <a:fillRect/>
          </a:stretch>
        </p:blipFill>
        <p:spPr>
          <a:xfrm>
            <a:off x="6863963" y="1960391"/>
            <a:ext cx="4922651" cy="395263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7551F6F-F441-F077-3237-3A35EEB32291}"/>
              </a:ext>
            </a:extLst>
          </p:cNvPr>
          <p:cNvSpPr txBox="1"/>
          <p:nvPr/>
        </p:nvSpPr>
        <p:spPr>
          <a:xfrm>
            <a:off x="405385" y="944974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C78BB51-DAD5-9A0C-9F80-606F3579780F}"/>
              </a:ext>
            </a:extLst>
          </p:cNvPr>
          <p:cNvSpPr txBox="1"/>
          <p:nvPr/>
        </p:nvSpPr>
        <p:spPr>
          <a:xfrm>
            <a:off x="6863964" y="944974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81C6AAF-4A1E-6B17-D240-E664EF928A67}"/>
              </a:ext>
            </a:extLst>
          </p:cNvPr>
          <p:cNvSpPr txBox="1"/>
          <p:nvPr/>
        </p:nvSpPr>
        <p:spPr>
          <a:xfrm>
            <a:off x="7730598" y="1237239"/>
            <a:ext cx="29092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Tissue (N = 30) PCA plot</a:t>
            </a:r>
            <a:endParaRPr lang="en-AU" sz="2000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0D99D65-04E4-171B-864A-936FC42CA016}"/>
              </a:ext>
            </a:extLst>
          </p:cNvPr>
          <p:cNvSpPr txBox="1"/>
          <p:nvPr/>
        </p:nvSpPr>
        <p:spPr>
          <a:xfrm>
            <a:off x="1765662" y="1978965"/>
            <a:ext cx="288681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HMPC (N = 30) PCA plot</a:t>
            </a:r>
            <a:endParaRPr lang="en-AU" sz="2000" b="1" dirty="0"/>
          </a:p>
        </p:txBody>
      </p:sp>
    </p:spTree>
    <p:extLst>
      <p:ext uri="{BB962C8B-B14F-4D97-AF65-F5344CB8AC3E}">
        <p14:creationId xmlns:p14="http://schemas.microsoft.com/office/powerpoint/2010/main" val="42356665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817D37F-B631-DBA0-6A41-8DC4C9D8FCE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AutoShape 2">
            <a:extLst>
              <a:ext uri="{FF2B5EF4-FFF2-40B4-BE49-F238E27FC236}">
                <a16:creationId xmlns:a16="http://schemas.microsoft.com/office/drawing/2014/main" id="{2A44B5A7-C359-9551-F5F6-90E24CCBB81A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5943600" y="3276600"/>
            <a:ext cx="304800" cy="30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pic>
        <p:nvPicPr>
          <p:cNvPr id="25" name="Picture 24" descr="A diagram of a box diagram&#10;&#10;AI-generated content may be incorrect.">
            <a:extLst>
              <a:ext uri="{FF2B5EF4-FFF2-40B4-BE49-F238E27FC236}">
                <a16:creationId xmlns:a16="http://schemas.microsoft.com/office/drawing/2014/main" id="{0A9C2E6F-18AB-2298-EF49-AB4DF2B679C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485" y="563642"/>
            <a:ext cx="4000500" cy="2857500"/>
          </a:xfrm>
          <a:prstGeom prst="rect">
            <a:avLst/>
          </a:prstGeom>
        </p:spPr>
      </p:pic>
      <p:pic>
        <p:nvPicPr>
          <p:cNvPr id="27" name="Picture 26" descr="A diagram of a box diagram&#10;&#10;AI-generated content may be incorrect.">
            <a:extLst>
              <a:ext uri="{FF2B5EF4-FFF2-40B4-BE49-F238E27FC236}">
                <a16:creationId xmlns:a16="http://schemas.microsoft.com/office/drawing/2014/main" id="{D0781675-93A3-94DE-34F2-602A6BFAABE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03399" y="571500"/>
            <a:ext cx="4000500" cy="2857500"/>
          </a:xfrm>
          <a:prstGeom prst="rect">
            <a:avLst/>
          </a:prstGeom>
        </p:spPr>
      </p:pic>
      <p:pic>
        <p:nvPicPr>
          <p:cNvPr id="29" name="Picture 28" descr="A diagram of a box diagram&#10;&#10;AI-generated content may be incorrect.">
            <a:extLst>
              <a:ext uri="{FF2B5EF4-FFF2-40B4-BE49-F238E27FC236}">
                <a16:creationId xmlns:a16="http://schemas.microsoft.com/office/drawing/2014/main" id="{CD7FD4FC-6E1D-279D-D3BD-B3BA013F3D9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53313" y="624817"/>
            <a:ext cx="4000500" cy="2857500"/>
          </a:xfrm>
          <a:prstGeom prst="rect">
            <a:avLst/>
          </a:prstGeom>
        </p:spPr>
      </p:pic>
      <p:pic>
        <p:nvPicPr>
          <p:cNvPr id="31" name="Picture 30" descr="A diagram of a cell&#10;&#10;AI-generated content may be incorrect.">
            <a:extLst>
              <a:ext uri="{FF2B5EF4-FFF2-40B4-BE49-F238E27FC236}">
                <a16:creationId xmlns:a16="http://schemas.microsoft.com/office/drawing/2014/main" id="{A136B37F-FABF-2913-64B7-7726A2C4EC2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91500" y="3778583"/>
            <a:ext cx="4000500" cy="2857500"/>
          </a:xfrm>
          <a:prstGeom prst="rect">
            <a:avLst/>
          </a:prstGeom>
        </p:spPr>
      </p:pic>
      <p:pic>
        <p:nvPicPr>
          <p:cNvPr id="33" name="Picture 32" descr="A diagram of a box diagram&#10;&#10;AI-generated content may be incorrect.">
            <a:extLst>
              <a:ext uri="{FF2B5EF4-FFF2-40B4-BE49-F238E27FC236}">
                <a16:creationId xmlns:a16="http://schemas.microsoft.com/office/drawing/2014/main" id="{3DEECC48-B632-1F30-FBCE-72F4EEE1DA9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485" y="3831900"/>
            <a:ext cx="4000500" cy="2857500"/>
          </a:xfrm>
          <a:prstGeom prst="rect">
            <a:avLst/>
          </a:prstGeom>
        </p:spPr>
      </p:pic>
      <p:pic>
        <p:nvPicPr>
          <p:cNvPr id="35" name="Picture 34" descr="A diagram of a box diagram&#10;&#10;AI-generated content may be incorrect.">
            <a:extLst>
              <a:ext uri="{FF2B5EF4-FFF2-40B4-BE49-F238E27FC236}">
                <a16:creationId xmlns:a16="http://schemas.microsoft.com/office/drawing/2014/main" id="{54674B7B-DD19-006E-4641-6B77653AA87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95750" y="3778583"/>
            <a:ext cx="4000500" cy="2857500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8C5B60F4-BB4D-208E-EF55-0F11721A2EAE}"/>
              </a:ext>
            </a:extLst>
          </p:cNvPr>
          <p:cNvSpPr txBox="1"/>
          <p:nvPr/>
        </p:nvSpPr>
        <p:spPr>
          <a:xfrm>
            <a:off x="53485" y="0"/>
            <a:ext cx="31832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Supplementary Figure 3 (1/3)</a:t>
            </a:r>
          </a:p>
        </p:txBody>
      </p:sp>
    </p:spTree>
    <p:extLst>
      <p:ext uri="{BB962C8B-B14F-4D97-AF65-F5344CB8AC3E}">
        <p14:creationId xmlns:p14="http://schemas.microsoft.com/office/powerpoint/2010/main" val="306728413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4070FFB4-5C3E-9650-2301-05ED3FFC6AE5}"/>
              </a:ext>
            </a:extLst>
          </p:cNvPr>
          <p:cNvSpPr txBox="1"/>
          <p:nvPr/>
        </p:nvSpPr>
        <p:spPr>
          <a:xfrm>
            <a:off x="53485" y="0"/>
            <a:ext cx="3229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Supplementary Figure 3  (2/3)</a:t>
            </a:r>
          </a:p>
        </p:txBody>
      </p:sp>
      <p:pic>
        <p:nvPicPr>
          <p:cNvPr id="23" name="Picture 22" descr="A diagram of a box diagram&#10;&#10;AI-generated content may be incorrect.">
            <a:extLst>
              <a:ext uri="{FF2B5EF4-FFF2-40B4-BE49-F238E27FC236}">
                <a16:creationId xmlns:a16="http://schemas.microsoft.com/office/drawing/2014/main" id="{67720137-15FE-D282-41EB-DECAAA2DF0C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91500" y="3839084"/>
            <a:ext cx="4000500" cy="2857500"/>
          </a:xfrm>
          <a:prstGeom prst="rect">
            <a:avLst/>
          </a:prstGeom>
        </p:spPr>
      </p:pic>
      <p:pic>
        <p:nvPicPr>
          <p:cNvPr id="21" name="Picture 20" descr="A diagram of a cell tissue&#10;&#10;AI-generated content may be incorrect.">
            <a:extLst>
              <a:ext uri="{FF2B5EF4-FFF2-40B4-BE49-F238E27FC236}">
                <a16:creationId xmlns:a16="http://schemas.microsoft.com/office/drawing/2014/main" id="{20C44E3E-9C44-471B-1B02-CF9E78E33DC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7517" y="3839084"/>
            <a:ext cx="4000500" cy="2857500"/>
          </a:xfrm>
          <a:prstGeom prst="rect">
            <a:avLst/>
          </a:prstGeom>
        </p:spPr>
      </p:pic>
      <p:pic>
        <p:nvPicPr>
          <p:cNvPr id="19" name="Picture 18" descr="A diagram of a box diagram&#10;&#10;AI-generated content may be incorrect.">
            <a:extLst>
              <a:ext uri="{FF2B5EF4-FFF2-40B4-BE49-F238E27FC236}">
                <a16:creationId xmlns:a16="http://schemas.microsoft.com/office/drawing/2014/main" id="{798F32A9-C2E8-E4DF-52A3-A8060D465B9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25" y="3839084"/>
            <a:ext cx="4000500" cy="2857500"/>
          </a:xfrm>
          <a:prstGeom prst="rect">
            <a:avLst/>
          </a:prstGeom>
        </p:spPr>
      </p:pic>
      <p:pic>
        <p:nvPicPr>
          <p:cNvPr id="17" name="Picture 16" descr="A diagram of a box diagram&#10;&#10;AI-generated content may be incorrect.">
            <a:extLst>
              <a:ext uri="{FF2B5EF4-FFF2-40B4-BE49-F238E27FC236}">
                <a16:creationId xmlns:a16="http://schemas.microsoft.com/office/drawing/2014/main" id="{652FDFFE-4782-4146-C1A1-5A19CFED316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91500" y="571500"/>
            <a:ext cx="4000500" cy="2857500"/>
          </a:xfrm>
          <a:prstGeom prst="rect">
            <a:avLst/>
          </a:prstGeom>
        </p:spPr>
      </p:pic>
      <p:pic>
        <p:nvPicPr>
          <p:cNvPr id="15" name="Picture 14" descr="A diagram of a box diagram&#10;&#10;AI-generated content may be incorrect.">
            <a:extLst>
              <a:ext uri="{FF2B5EF4-FFF2-40B4-BE49-F238E27FC236}">
                <a16:creationId xmlns:a16="http://schemas.microsoft.com/office/drawing/2014/main" id="{930812D5-C1DF-EDC6-45C4-6C8847DFBF1C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7517" y="571500"/>
            <a:ext cx="4000500" cy="2857500"/>
          </a:xfrm>
          <a:prstGeom prst="rect">
            <a:avLst/>
          </a:prstGeom>
        </p:spPr>
      </p:pic>
      <p:pic>
        <p:nvPicPr>
          <p:cNvPr id="13" name="Picture 12" descr="A diagram of a box diagram&#10;&#10;AI-generated content may be incorrect.">
            <a:extLst>
              <a:ext uri="{FF2B5EF4-FFF2-40B4-BE49-F238E27FC236}">
                <a16:creationId xmlns:a16="http://schemas.microsoft.com/office/drawing/2014/main" id="{08DA4943-BC97-A8C7-6B6F-520A0FA82E17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485" y="571500"/>
            <a:ext cx="4000500" cy="2857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431965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 descr="A diagram of a box diagram&#10;&#10;AI-generated content may be incorrect.">
            <a:extLst>
              <a:ext uri="{FF2B5EF4-FFF2-40B4-BE49-F238E27FC236}">
                <a16:creationId xmlns:a16="http://schemas.microsoft.com/office/drawing/2014/main" id="{F7F855B8-330E-9C88-C66E-09BAEE13BA2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485" y="464179"/>
            <a:ext cx="4000500" cy="28575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09420DB-C875-D043-3EA4-0C28A924366A}"/>
              </a:ext>
            </a:extLst>
          </p:cNvPr>
          <p:cNvSpPr txBox="1"/>
          <p:nvPr/>
        </p:nvSpPr>
        <p:spPr>
          <a:xfrm>
            <a:off x="53485" y="0"/>
            <a:ext cx="3229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Supplementary Figure 3  (3/3)</a:t>
            </a:r>
          </a:p>
        </p:txBody>
      </p:sp>
    </p:spTree>
    <p:extLst>
      <p:ext uri="{BB962C8B-B14F-4D97-AF65-F5344CB8AC3E}">
        <p14:creationId xmlns:p14="http://schemas.microsoft.com/office/powerpoint/2010/main" val="13545143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3363575A-31A0-5A6A-3AC5-7F20083CC554}"/>
              </a:ext>
            </a:extLst>
          </p:cNvPr>
          <p:cNvSpPr txBox="1"/>
          <p:nvPr/>
        </p:nvSpPr>
        <p:spPr>
          <a:xfrm>
            <a:off x="262890" y="247888"/>
            <a:ext cx="31832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Supplementary Figure 4 (1/4)</a:t>
            </a:r>
          </a:p>
        </p:txBody>
      </p:sp>
      <p:pic>
        <p:nvPicPr>
          <p:cNvPr id="4" name="Picture 3" descr="A graph of different colored bars&#10;&#10;Description automatically generated with medium confidence">
            <a:extLst>
              <a:ext uri="{FF2B5EF4-FFF2-40B4-BE49-F238E27FC236}">
                <a16:creationId xmlns:a16="http://schemas.microsoft.com/office/drawing/2014/main" id="{9B198ABB-9B98-1AB1-7DD9-507FF6DF5D9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391" y="1692595"/>
            <a:ext cx="3817969" cy="4491728"/>
          </a:xfrm>
          <a:prstGeom prst="rect">
            <a:avLst/>
          </a:prstGeom>
        </p:spPr>
      </p:pic>
      <p:pic>
        <p:nvPicPr>
          <p:cNvPr id="10" name="Picture 9" descr="A graph of a number of different colored bars&#10;&#10;Description automatically generated with medium confidence">
            <a:extLst>
              <a:ext uri="{FF2B5EF4-FFF2-40B4-BE49-F238E27FC236}">
                <a16:creationId xmlns:a16="http://schemas.microsoft.com/office/drawing/2014/main" id="{D6176A6B-7B43-FDB3-A22F-F616B63FA43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21116" y="1692595"/>
            <a:ext cx="3817969" cy="4491729"/>
          </a:xfrm>
          <a:prstGeom prst="rect">
            <a:avLst/>
          </a:prstGeom>
        </p:spPr>
      </p:pic>
      <p:pic>
        <p:nvPicPr>
          <p:cNvPr id="12" name="Picture 11" descr="A graph of a diagram&#10;&#10;Description automatically generated with medium confidence">
            <a:extLst>
              <a:ext uri="{FF2B5EF4-FFF2-40B4-BE49-F238E27FC236}">
                <a16:creationId xmlns:a16="http://schemas.microsoft.com/office/drawing/2014/main" id="{76949B7B-B3DA-2926-C456-0ECA3F21080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68672" y="1692595"/>
            <a:ext cx="3817968" cy="44917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9844097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EC36579-EEEF-9203-316B-0BBF3D7BB9F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5B70C82-C4AD-4108-40CE-A9747C76DF3E}"/>
              </a:ext>
            </a:extLst>
          </p:cNvPr>
          <p:cNvSpPr txBox="1"/>
          <p:nvPr/>
        </p:nvSpPr>
        <p:spPr>
          <a:xfrm>
            <a:off x="262890" y="247888"/>
            <a:ext cx="31832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Supplementary Figure 4 (2/4)</a:t>
            </a:r>
          </a:p>
        </p:txBody>
      </p:sp>
      <p:pic>
        <p:nvPicPr>
          <p:cNvPr id="6" name="Picture 5" descr="A graph of different colored bars&#10;&#10;Description automatically generated with medium confidence">
            <a:extLst>
              <a:ext uri="{FF2B5EF4-FFF2-40B4-BE49-F238E27FC236}">
                <a16:creationId xmlns:a16="http://schemas.microsoft.com/office/drawing/2014/main" id="{BE27BED1-576E-E005-7E10-C86F82C9360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9208" y="1793899"/>
            <a:ext cx="3755591" cy="4418343"/>
          </a:xfrm>
          <a:prstGeom prst="rect">
            <a:avLst/>
          </a:prstGeom>
        </p:spPr>
      </p:pic>
      <p:pic>
        <p:nvPicPr>
          <p:cNvPr id="9" name="Picture 8" descr="A graph of different colored bars&#10;&#10;Description automatically generated with medium confidence">
            <a:extLst>
              <a:ext uri="{FF2B5EF4-FFF2-40B4-BE49-F238E27FC236}">
                <a16:creationId xmlns:a16="http://schemas.microsoft.com/office/drawing/2014/main" id="{C3DE65A8-7649-E3A6-72FD-EACD5979474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87351" y="1793898"/>
            <a:ext cx="3755592" cy="4418344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36A29B2A-D994-0A2F-EC1F-F6591F9465F0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50361" r="-1" b="50000"/>
          <a:stretch/>
        </p:blipFill>
        <p:spPr>
          <a:xfrm>
            <a:off x="7805495" y="1793898"/>
            <a:ext cx="4386505" cy="44183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8971819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0A88245-8CDE-155F-F055-B3E1931F8CB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35D559E-B9BA-77A0-DF6A-A9B074E719EE}"/>
              </a:ext>
            </a:extLst>
          </p:cNvPr>
          <p:cNvSpPr txBox="1"/>
          <p:nvPr/>
        </p:nvSpPr>
        <p:spPr>
          <a:xfrm>
            <a:off x="262890" y="247888"/>
            <a:ext cx="31832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Supplementary Figure 4 (3/4)</a:t>
            </a:r>
          </a:p>
        </p:txBody>
      </p:sp>
      <p:pic>
        <p:nvPicPr>
          <p:cNvPr id="4" name="Picture 3" descr="A graph of a number of cells&#10;&#10;Description automatically generated with medium confidence">
            <a:extLst>
              <a:ext uri="{FF2B5EF4-FFF2-40B4-BE49-F238E27FC236}">
                <a16:creationId xmlns:a16="http://schemas.microsoft.com/office/drawing/2014/main" id="{DA20FDCF-AC3F-591F-11DC-37C221DFAB1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890" y="1636753"/>
            <a:ext cx="3728972" cy="4387026"/>
          </a:xfrm>
          <a:prstGeom prst="rect">
            <a:avLst/>
          </a:prstGeom>
        </p:spPr>
      </p:pic>
      <p:pic>
        <p:nvPicPr>
          <p:cNvPr id="10" name="Picture 9" descr="A graph of a number of different colored bars&#10;&#10;Description automatically generated with medium confidence">
            <a:extLst>
              <a:ext uri="{FF2B5EF4-FFF2-40B4-BE49-F238E27FC236}">
                <a16:creationId xmlns:a16="http://schemas.microsoft.com/office/drawing/2014/main" id="{5E09DED1-BEA7-2BA2-8A90-4B264379ADB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17496" y="1638498"/>
            <a:ext cx="3728972" cy="4387026"/>
          </a:xfrm>
          <a:prstGeom prst="rect">
            <a:avLst/>
          </a:prstGeom>
        </p:spPr>
      </p:pic>
      <p:pic>
        <p:nvPicPr>
          <p:cNvPr id="12" name="Picture 11" descr="A graph of different colored squares&#10;&#10;Description automatically generated">
            <a:extLst>
              <a:ext uri="{FF2B5EF4-FFF2-40B4-BE49-F238E27FC236}">
                <a16:creationId xmlns:a16="http://schemas.microsoft.com/office/drawing/2014/main" id="{E2451FB0-EF81-FE83-AA3F-0AD3C4E677A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72103" y="1636753"/>
            <a:ext cx="3728972" cy="43870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481551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786</TotalTime>
  <Words>109</Words>
  <Application>Microsoft Office PowerPoint</Application>
  <PresentationFormat>Widescreen</PresentationFormat>
  <Paragraphs>24</Paragraphs>
  <Slides>12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6" baseType="lpstr">
      <vt:lpstr>Aptos</vt:lpstr>
      <vt:lpstr>Aptos Display</vt:lpstr>
      <vt:lpstr>Arial</vt:lpstr>
      <vt:lpstr>Office Theme</vt:lpstr>
      <vt:lpstr>The transcriptomic signature of age and sex is not conserved in human primary myocytes   Lamon S. et al.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Deakin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everine Lamon</dc:creator>
  <cp:lastModifiedBy>Severine Lamon</cp:lastModifiedBy>
  <cp:revision>85</cp:revision>
  <dcterms:created xsi:type="dcterms:W3CDTF">2024-10-16T10:02:31Z</dcterms:created>
  <dcterms:modified xsi:type="dcterms:W3CDTF">2025-06-25T22:01:20Z</dcterms:modified>
</cp:coreProperties>
</file>